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anzQC-JF" initials="JF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60" y="8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CE91D1-E404-4EAB-9FB6-C6531D0D406C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936C8-C058-4491-BDDA-56099C80B6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67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8936C8-C058-4491-BDDA-56099C80B65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8142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5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00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6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43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886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34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42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64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205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582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5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41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/>
          <p:cNvSpPr txBox="1"/>
          <p:nvPr/>
        </p:nvSpPr>
        <p:spPr>
          <a:xfrm>
            <a:off x="-27384" y="-887"/>
            <a:ext cx="23038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220262" y="3058316"/>
            <a:ext cx="6417477" cy="5913496"/>
            <a:chOff x="183665" y="530712"/>
            <a:chExt cx="6417477" cy="5913496"/>
          </a:xfrm>
        </p:grpSpPr>
        <p:sp>
          <p:nvSpPr>
            <p:cNvPr id="22" name="テキスト ボックス 21"/>
            <p:cNvSpPr txBox="1"/>
            <p:nvPr/>
          </p:nvSpPr>
          <p:spPr>
            <a:xfrm>
              <a:off x="183665" y="2816371"/>
              <a:ext cx="16193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lubilization</a:t>
              </a:r>
              <a:endPara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9" name="グループ化 18"/>
            <p:cNvGrpSpPr/>
            <p:nvPr/>
          </p:nvGrpSpPr>
          <p:grpSpPr>
            <a:xfrm>
              <a:off x="5393176" y="2330460"/>
              <a:ext cx="1204176" cy="1398611"/>
              <a:chOff x="5393176" y="2330460"/>
              <a:chExt cx="1204176" cy="1398611"/>
            </a:xfrm>
          </p:grpSpPr>
          <p:sp>
            <p:nvSpPr>
              <p:cNvPr id="32" name="テキスト ボックス 31"/>
              <p:cNvSpPr txBox="1"/>
              <p:nvPr/>
            </p:nvSpPr>
            <p:spPr>
              <a:xfrm>
                <a:off x="5393176" y="2842292"/>
                <a:ext cx="12041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% </a:t>
                </a:r>
                <a:r>
                  <a:rPr lang="en-US" altLang="ja-JP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tOH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5393176" y="3359739"/>
                <a:ext cx="9733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SDS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5393176" y="2330460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W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" name="テキスト ボックス 20"/>
            <p:cNvSpPr txBox="1"/>
            <p:nvPr/>
          </p:nvSpPr>
          <p:spPr>
            <a:xfrm>
              <a:off x="183665" y="1055483"/>
              <a:ext cx="1084143" cy="4401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V stain</a:t>
              </a:r>
              <a:endParaRPr kumimoji="1"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7" name="グループ化 46"/>
            <p:cNvGrpSpPr/>
            <p:nvPr/>
          </p:nvGrpSpPr>
          <p:grpSpPr>
            <a:xfrm>
              <a:off x="2163675" y="5549411"/>
              <a:ext cx="3100409" cy="894797"/>
              <a:chOff x="2113454" y="7322488"/>
              <a:chExt cx="3100409" cy="894797"/>
            </a:xfrm>
          </p:grpSpPr>
          <p:sp>
            <p:nvSpPr>
              <p:cNvPr id="6" name="テキスト ボックス 5"/>
              <p:cNvSpPr txBox="1"/>
              <p:nvPr/>
            </p:nvSpPr>
            <p:spPr>
              <a:xfrm rot="18363936">
                <a:off x="1967260" y="7631388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277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 rot="18363936">
                <a:off x="2306379" y="7539054"/>
                <a:ext cx="89479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274</a:t>
                </a:r>
              </a:p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 rot="18363936">
                <a:off x="2879448" y="7539054"/>
                <a:ext cx="89479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319</a:t>
                </a:r>
              </a:p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テキスト ボックス 8"/>
              <p:cNvSpPr txBox="1"/>
              <p:nvPr/>
            </p:nvSpPr>
            <p:spPr>
              <a:xfrm rot="18363936">
                <a:off x="3527520" y="7539054"/>
                <a:ext cx="89479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450</a:t>
                </a:r>
              </a:p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 rot="18363936">
                <a:off x="4031576" y="7539054"/>
                <a:ext cx="89479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970</a:t>
                </a:r>
              </a:p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 rot="18363936">
                <a:off x="4535632" y="7539054"/>
                <a:ext cx="89479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1740</a:t>
                </a:r>
              </a:p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" name="テキスト ボックス 38"/>
            <p:cNvSpPr txBox="1"/>
            <p:nvPr/>
          </p:nvSpPr>
          <p:spPr>
            <a:xfrm>
              <a:off x="183665" y="4391920"/>
              <a:ext cx="1415772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the</a:t>
              </a:r>
            </a:p>
            <a:p>
              <a:r>
                <a:rPr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lution</a:t>
              </a: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07205" y="530712"/>
              <a:ext cx="3158864" cy="1512168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07205" y="2273494"/>
              <a:ext cx="3158864" cy="1503691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05220" y="4007798"/>
              <a:ext cx="3162835" cy="1491466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42" name="グループ化 41"/>
            <p:cNvGrpSpPr/>
            <p:nvPr/>
          </p:nvGrpSpPr>
          <p:grpSpPr>
            <a:xfrm>
              <a:off x="5396966" y="4049360"/>
              <a:ext cx="1204176" cy="1398611"/>
              <a:chOff x="5393176" y="2330460"/>
              <a:chExt cx="1204176" cy="1398611"/>
            </a:xfrm>
          </p:grpSpPr>
          <p:sp>
            <p:nvSpPr>
              <p:cNvPr id="43" name="テキスト ボックス 42"/>
              <p:cNvSpPr txBox="1"/>
              <p:nvPr/>
            </p:nvSpPr>
            <p:spPr>
              <a:xfrm>
                <a:off x="5393176" y="2842292"/>
                <a:ext cx="12041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% </a:t>
                </a:r>
                <a:r>
                  <a:rPr lang="en-US" altLang="ja-JP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tOH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5393176" y="3359739"/>
                <a:ext cx="9733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SDS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>
                <a:off x="5393176" y="2330460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W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" name="テキスト ボックス 2"/>
          <p:cNvSpPr txBox="1"/>
          <p:nvPr/>
        </p:nvSpPr>
        <p:spPr>
          <a:xfrm>
            <a:off x="212415" y="809581"/>
            <a:ext cx="641698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- Comparisons of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film treated with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hanol or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S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pper panel) Pre-ethanol or SDS treated biofilm; (middle panel) Post-ethanol or SDS </a:t>
            </a:r>
            <a:endParaRPr lang="en-US" altLang="ja-JP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film; (lower panel)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moval of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olution. 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9596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76</Words>
  <Application>Microsoft Office PowerPoint</Application>
  <PresentationFormat>画面に合わせる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池有一郎</dc:creator>
  <cp:lastModifiedBy>菊池有一郎</cp:lastModifiedBy>
  <cp:revision>49</cp:revision>
  <cp:lastPrinted>2014-11-25T09:31:52Z</cp:lastPrinted>
  <dcterms:created xsi:type="dcterms:W3CDTF">2014-12-22T02:55:55Z</dcterms:created>
  <dcterms:modified xsi:type="dcterms:W3CDTF">2015-01-05T01:49:08Z</dcterms:modified>
</cp:coreProperties>
</file>